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04BE6BA-867F-41C2-9151-95A48448273C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32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1. DNAase I footprinting of SpoIIID binding to the promoters of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spoIID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,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spoIIIA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spoV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7CD6DD-553C-4D15-99D2-FD3237A317D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1F8E80-EE89-4E2B-B36B-1259F42FE3B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B34A40-1186-4517-A7B7-5BC324783DE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CA6A18-CDB5-43B9-8ADD-BFAD1C1E2A4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F303AF-376B-409C-992C-BE7479FEA5E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3A0E7C-D3E9-44BF-B046-967F623EB19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FEC941-14E8-44C1-A888-4733204DA5D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46D37B-23D6-4F2D-8143-7487F3595F0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568C75-0C41-46C2-B202-1CD6634A43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442368-611D-4EE5-8D37-E4C0A50751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E09A11-FFB8-40A7-82D2-1D856D86E5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814674-E7F5-463F-BD52-6BC8F71107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FD52F30-E5BF-416E-A7DE-708BA0AFD0D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png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png"/><Relationship Id="rId13" Type="http://schemas.openxmlformats.org/officeDocument/2006/relationships/slideLayout" Target="../slideLayouts/slideLayout1.xml"/><Relationship Id="rId1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"/>
          <p:cNvSpPr/>
          <p:nvPr/>
        </p:nvSpPr>
        <p:spPr>
          <a:xfrm>
            <a:off x="916200" y="895320"/>
            <a:ext cx="231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602000" y="914400"/>
            <a:ext cx="231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2592720" y="914400"/>
            <a:ext cx="231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202200" y="914400"/>
            <a:ext cx="231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102680" y="914400"/>
            <a:ext cx="26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788480" y="914400"/>
            <a:ext cx="26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779200" y="914400"/>
            <a:ext cx="26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3388680" y="914400"/>
            <a:ext cx="26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143720" y="447840"/>
            <a:ext cx="698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Times New Roman"/>
              </a:rPr>
              <a:t>spoII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667240" y="447840"/>
            <a:ext cx="759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Times New Roman"/>
              </a:rPr>
              <a:t>spoIII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917880" y="447840"/>
            <a:ext cx="925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Times New Roman"/>
              </a:rPr>
              <a:t>spoVE-P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915840" y="72396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to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1449720" y="723960"/>
            <a:ext cx="645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botto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2592360" y="72396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to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125880" y="723960"/>
            <a:ext cx="645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botto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4167000" y="72396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to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5062680" y="723960"/>
            <a:ext cx="645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botto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1371600" y="1371600"/>
            <a:ext cx="0" cy="6094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1371600" y="2286000"/>
            <a:ext cx="0" cy="1143000"/>
          </a:xfrm>
          <a:prstGeom prst="line">
            <a:avLst/>
          </a:prstGeom>
          <a:ln w="381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3048120" y="1371600"/>
            <a:ext cx="0" cy="5335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3657600" y="1447920"/>
            <a:ext cx="0" cy="6094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9" name=""/>
          <p:cNvGrpSpPr/>
          <p:nvPr/>
        </p:nvGrpSpPr>
        <p:grpSpPr>
          <a:xfrm>
            <a:off x="305280" y="4373640"/>
            <a:ext cx="6125760" cy="398520"/>
            <a:chOff x="305280" y="4373640"/>
            <a:chExt cx="6125760" cy="398520"/>
          </a:xfrm>
        </p:grpSpPr>
        <p:sp>
          <p:nvSpPr>
            <p:cNvPr id="70" name=""/>
            <p:cNvSpPr/>
            <p:nvPr/>
          </p:nvSpPr>
          <p:spPr>
            <a:xfrm>
              <a:off x="1068120" y="4373640"/>
              <a:ext cx="536292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</a:rPr>
                <a:t>5’-ataaagt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</a:rPr>
                <a:t>TTCTGTCCAA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</a:rPr>
                <a:t>aacgagagtcatatta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</a:rPr>
                <a:t>GCTTGTCCCT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</a:rPr>
                <a:t>gcccatagactagactaG-3’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</a:rPr>
                <a:t>3’-tatttca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</a:rPr>
                <a:t>AAGACAGGTT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</a:rPr>
                <a:t>ttgctctcagtataat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</a:rPr>
                <a:t>CGAACAGGGA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</a:rPr>
                <a:t>cgggtatctgatctgatC-5’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305280" y="4433760"/>
              <a:ext cx="621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</a:rPr>
                <a:t>spoII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2" name=""/>
          <p:cNvGrpSpPr/>
          <p:nvPr/>
        </p:nvGrpSpPr>
        <p:grpSpPr>
          <a:xfrm>
            <a:off x="304920" y="4946760"/>
            <a:ext cx="5668560" cy="398520"/>
            <a:chOff x="304920" y="4946760"/>
            <a:chExt cx="5668560" cy="398520"/>
          </a:xfrm>
        </p:grpSpPr>
        <p:sp>
          <p:nvSpPr>
            <p:cNvPr id="73" name=""/>
            <p:cNvSpPr/>
            <p:nvPr/>
          </p:nvSpPr>
          <p:spPr>
            <a:xfrm>
              <a:off x="1068120" y="4946760"/>
              <a:ext cx="490536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</a:rPr>
                <a:t>5’-cataaataaagagag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</a:rPr>
                <a:t>GCTTGTCATA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</a:rPr>
                <a:t>aagtctgcctcacatcatacattttaaagA-3’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</a:rPr>
                <a:t>3’-gtatttatttctctc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</a:rPr>
                <a:t>CGAACAGTAT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</a:rPr>
                <a:t>ttcagacggagtgtagtatgtaaaatttcT-5’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304920" y="5008680"/>
              <a:ext cx="672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</a:rPr>
                <a:t>spoIII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5" name=""/>
          <p:cNvGrpSpPr/>
          <p:nvPr/>
        </p:nvGrpSpPr>
        <p:grpSpPr>
          <a:xfrm>
            <a:off x="306000" y="5521320"/>
            <a:ext cx="5972400" cy="398520"/>
            <a:chOff x="306000" y="5521320"/>
            <a:chExt cx="5972400" cy="398520"/>
          </a:xfrm>
        </p:grpSpPr>
        <p:sp>
          <p:nvSpPr>
            <p:cNvPr id="76" name=""/>
            <p:cNvSpPr/>
            <p:nvPr/>
          </p:nvSpPr>
          <p:spPr>
            <a:xfrm>
              <a:off x="1068480" y="5521320"/>
              <a:ext cx="520992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</a:rPr>
                <a:t>5’-gggaatacaacatgtcaaacgtgtcgataatg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</a:rPr>
                <a:t>TTGAACAAGC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</a:rPr>
                <a:t>agtatctgcggcgtttg-3’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</a:rPr>
                <a:t>3’-cccttatgttgtacagtttgcacagctattac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</a:rPr>
                <a:t>AACTTGTTCG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</a:rPr>
                <a:t>tcatagacgccgcaaac-5’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306000" y="5583240"/>
              <a:ext cx="816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</a:rPr>
                <a:t>spoVE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-P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8" name=""/>
          <p:cNvGrpSpPr/>
          <p:nvPr/>
        </p:nvGrpSpPr>
        <p:grpSpPr>
          <a:xfrm>
            <a:off x="306000" y="6095880"/>
            <a:ext cx="5972400" cy="398520"/>
            <a:chOff x="306000" y="6095880"/>
            <a:chExt cx="5972400" cy="398520"/>
          </a:xfrm>
        </p:grpSpPr>
        <p:sp>
          <p:nvSpPr>
            <p:cNvPr id="79" name=""/>
            <p:cNvSpPr/>
            <p:nvPr/>
          </p:nvSpPr>
          <p:spPr>
            <a:xfrm>
              <a:off x="1068480" y="6095880"/>
              <a:ext cx="520992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</a:rPr>
                <a:t>5’-ggtgacatgtttatagatgccgtgcatatgcttaagtaAgg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</a:rPr>
                <a:t>GCTTGTCTTG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</a:rPr>
                <a:t>aagtaaat-3’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</a:rPr>
                <a:t>3’-ccactgtacaaatatctacggcacgtatacgaattcatTcc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</a:rPr>
                <a:t>CGAACAGAAC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</a:rPr>
                <a:t>ttcattta-5’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306000" y="6156000"/>
              <a:ext cx="816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</a:rPr>
                <a:t>spoVE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-P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1" name=""/>
          <p:cNvGrpSpPr/>
          <p:nvPr/>
        </p:nvGrpSpPr>
        <p:grpSpPr>
          <a:xfrm>
            <a:off x="5868360" y="4038480"/>
            <a:ext cx="380160" cy="381240"/>
            <a:chOff x="5868360" y="4038480"/>
            <a:chExt cx="380160" cy="381240"/>
          </a:xfrm>
        </p:grpSpPr>
        <p:grpSp>
          <p:nvGrpSpPr>
            <p:cNvPr id="82" name=""/>
            <p:cNvGrpSpPr/>
            <p:nvPr/>
          </p:nvGrpSpPr>
          <p:grpSpPr>
            <a:xfrm>
              <a:off x="6019920" y="4267080"/>
              <a:ext cx="228600" cy="152640"/>
              <a:chOff x="6019920" y="4267080"/>
              <a:chExt cx="228600" cy="152640"/>
            </a:xfrm>
          </p:grpSpPr>
          <p:sp>
            <p:nvSpPr>
              <p:cNvPr id="83" name=""/>
              <p:cNvSpPr/>
              <p:nvPr/>
            </p:nvSpPr>
            <p:spPr>
              <a:xfrm flipV="1">
                <a:off x="6019920" y="4267080"/>
                <a:ext cx="0" cy="1526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6019920" y="4267080"/>
                <a:ext cx="2286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5" name=""/>
            <p:cNvSpPr/>
            <p:nvPr/>
          </p:nvSpPr>
          <p:spPr>
            <a:xfrm>
              <a:off x="5868360" y="4038480"/>
              <a:ext cx="343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+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6" name=""/>
          <p:cNvGrpSpPr/>
          <p:nvPr/>
        </p:nvGrpSpPr>
        <p:grpSpPr>
          <a:xfrm>
            <a:off x="5411160" y="4648320"/>
            <a:ext cx="380160" cy="380160"/>
            <a:chOff x="5411160" y="4648320"/>
            <a:chExt cx="380160" cy="380160"/>
          </a:xfrm>
        </p:grpSpPr>
        <p:grpSp>
          <p:nvGrpSpPr>
            <p:cNvPr id="87" name=""/>
            <p:cNvGrpSpPr/>
            <p:nvPr/>
          </p:nvGrpSpPr>
          <p:grpSpPr>
            <a:xfrm>
              <a:off x="5562720" y="4876200"/>
              <a:ext cx="228600" cy="152280"/>
              <a:chOff x="5562720" y="4876200"/>
              <a:chExt cx="228600" cy="152280"/>
            </a:xfrm>
          </p:grpSpPr>
          <p:sp>
            <p:nvSpPr>
              <p:cNvPr id="88" name=""/>
              <p:cNvSpPr/>
              <p:nvPr/>
            </p:nvSpPr>
            <p:spPr>
              <a:xfrm flipV="1">
                <a:off x="5562720" y="4876200"/>
                <a:ext cx="0" cy="1522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5562720" y="4876560"/>
                <a:ext cx="2286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0" name=""/>
            <p:cNvSpPr/>
            <p:nvPr/>
          </p:nvSpPr>
          <p:spPr>
            <a:xfrm>
              <a:off x="5411160" y="4648320"/>
              <a:ext cx="343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+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1" name=""/>
          <p:cNvGrpSpPr/>
          <p:nvPr/>
        </p:nvGrpSpPr>
        <p:grpSpPr>
          <a:xfrm>
            <a:off x="4192200" y="5181480"/>
            <a:ext cx="379440" cy="381240"/>
            <a:chOff x="4192200" y="5181480"/>
            <a:chExt cx="379440" cy="381240"/>
          </a:xfrm>
        </p:grpSpPr>
        <p:grpSp>
          <p:nvGrpSpPr>
            <p:cNvPr id="92" name=""/>
            <p:cNvGrpSpPr/>
            <p:nvPr/>
          </p:nvGrpSpPr>
          <p:grpSpPr>
            <a:xfrm>
              <a:off x="4343400" y="5410080"/>
              <a:ext cx="228240" cy="152640"/>
              <a:chOff x="4343400" y="5410080"/>
              <a:chExt cx="228240" cy="152640"/>
            </a:xfrm>
          </p:grpSpPr>
          <p:sp>
            <p:nvSpPr>
              <p:cNvPr id="93" name=""/>
              <p:cNvSpPr/>
              <p:nvPr/>
            </p:nvSpPr>
            <p:spPr>
              <a:xfrm flipV="1">
                <a:off x="4343400" y="5410080"/>
                <a:ext cx="0" cy="1526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4343400" y="5410080"/>
                <a:ext cx="2282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5" name=""/>
            <p:cNvSpPr/>
            <p:nvPr/>
          </p:nvSpPr>
          <p:spPr>
            <a:xfrm>
              <a:off x="4192200" y="5181480"/>
              <a:ext cx="343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+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6" name=""/>
          <p:cNvGrpSpPr/>
          <p:nvPr/>
        </p:nvGrpSpPr>
        <p:grpSpPr>
          <a:xfrm>
            <a:off x="4192200" y="5791320"/>
            <a:ext cx="379440" cy="380160"/>
            <a:chOff x="4192200" y="5791320"/>
            <a:chExt cx="379440" cy="380160"/>
          </a:xfrm>
        </p:grpSpPr>
        <p:grpSp>
          <p:nvGrpSpPr>
            <p:cNvPr id="97" name=""/>
            <p:cNvGrpSpPr/>
            <p:nvPr/>
          </p:nvGrpSpPr>
          <p:grpSpPr>
            <a:xfrm>
              <a:off x="4343400" y="6019200"/>
              <a:ext cx="228240" cy="152280"/>
              <a:chOff x="4343400" y="6019200"/>
              <a:chExt cx="228240" cy="152280"/>
            </a:xfrm>
          </p:grpSpPr>
          <p:sp>
            <p:nvSpPr>
              <p:cNvPr id="98" name=""/>
              <p:cNvSpPr/>
              <p:nvPr/>
            </p:nvSpPr>
            <p:spPr>
              <a:xfrm flipV="1">
                <a:off x="4343400" y="6019200"/>
                <a:ext cx="0" cy="1522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4343400" y="6019560"/>
                <a:ext cx="2282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0" name=""/>
            <p:cNvSpPr/>
            <p:nvPr/>
          </p:nvSpPr>
          <p:spPr>
            <a:xfrm>
              <a:off x="4192200" y="5791320"/>
              <a:ext cx="343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+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1" name=""/>
          <p:cNvSpPr/>
          <p:nvPr/>
        </p:nvSpPr>
        <p:spPr>
          <a:xfrm>
            <a:off x="1981080" y="4419720"/>
            <a:ext cx="1524240" cy="0"/>
          </a:xfrm>
          <a:prstGeom prst="line">
            <a:avLst/>
          </a:prstGeom>
          <a:ln w="381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3809880" y="4419720"/>
            <a:ext cx="144792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3276720" y="4724280"/>
            <a:ext cx="137160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1981080" y="4952880"/>
            <a:ext cx="198144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1905120" y="5334120"/>
            <a:ext cx="14475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3733920" y="5562720"/>
            <a:ext cx="152388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4191120" y="6477120"/>
            <a:ext cx="129528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08" name=""/>
          <p:cNvGraphicFramePr/>
          <p:nvPr/>
        </p:nvGraphicFramePr>
        <p:xfrm>
          <a:off x="1600200" y="1143000"/>
          <a:ext cx="438120" cy="13525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09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600200" y="1143000"/>
                    <a:ext cx="438120" cy="1352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10" name=""/>
          <p:cNvGraphicFramePr/>
          <p:nvPr/>
        </p:nvGraphicFramePr>
        <p:xfrm>
          <a:off x="914400" y="1143000"/>
          <a:ext cx="438120" cy="25956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11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914400" y="1143000"/>
                    <a:ext cx="438120" cy="2595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12" name=""/>
          <p:cNvGraphicFramePr/>
          <p:nvPr/>
        </p:nvGraphicFramePr>
        <p:xfrm>
          <a:off x="2590920" y="1143000"/>
          <a:ext cx="438120" cy="107460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113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2590920" y="1143000"/>
                    <a:ext cx="438120" cy="1074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14" name=""/>
          <p:cNvSpPr/>
          <p:nvPr/>
        </p:nvSpPr>
        <p:spPr>
          <a:xfrm>
            <a:off x="2057400" y="1828800"/>
            <a:ext cx="0" cy="4572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15" name=""/>
          <p:cNvGraphicFramePr/>
          <p:nvPr/>
        </p:nvGraphicFramePr>
        <p:xfrm>
          <a:off x="3200400" y="1143000"/>
          <a:ext cx="438120" cy="126540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116" name="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3200400" y="1143000"/>
                    <a:ext cx="438120" cy="1265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117" name=""/>
          <p:cNvGrpSpPr/>
          <p:nvPr/>
        </p:nvGrpSpPr>
        <p:grpSpPr>
          <a:xfrm>
            <a:off x="5137200" y="895320"/>
            <a:ext cx="457200" cy="2359080"/>
            <a:chOff x="5137200" y="895320"/>
            <a:chExt cx="457200" cy="2359080"/>
          </a:xfrm>
        </p:grpSpPr>
        <p:sp>
          <p:nvSpPr>
            <p:cNvPr id="118" name=""/>
            <p:cNvSpPr/>
            <p:nvPr/>
          </p:nvSpPr>
          <p:spPr>
            <a:xfrm>
              <a:off x="5139000" y="895320"/>
              <a:ext cx="231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-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5290560" y="895320"/>
              <a:ext cx="26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5594400" y="1428840"/>
              <a:ext cx="0" cy="152388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121" name=""/>
            <p:cNvGraphicFramePr/>
            <p:nvPr/>
          </p:nvGraphicFramePr>
          <p:xfrm>
            <a:off x="5137200" y="1123920"/>
            <a:ext cx="438120" cy="2130480"/>
          </p:xfrm>
          <a:graphic>
            <a:graphicData uri="http://schemas.openxmlformats.org/presentationml/2006/ole">
              <p:oleObj r:id="rId9" spid="">
                <p:embed/>
                <p:pic>
                  <p:nvPicPr>
                    <p:cNvPr id="122" name="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5137200" y="1123920"/>
                      <a:ext cx="438120" cy="21304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</p:grpSp>
      <p:grpSp>
        <p:nvGrpSpPr>
          <p:cNvPr id="123" name=""/>
          <p:cNvGrpSpPr/>
          <p:nvPr/>
        </p:nvGrpSpPr>
        <p:grpSpPr>
          <a:xfrm>
            <a:off x="4165560" y="895320"/>
            <a:ext cx="457200" cy="1741320"/>
            <a:chOff x="4165560" y="895320"/>
            <a:chExt cx="457200" cy="1741320"/>
          </a:xfrm>
        </p:grpSpPr>
        <p:sp>
          <p:nvSpPr>
            <p:cNvPr id="124" name=""/>
            <p:cNvSpPr/>
            <p:nvPr/>
          </p:nvSpPr>
          <p:spPr>
            <a:xfrm>
              <a:off x="4167360" y="895320"/>
              <a:ext cx="231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-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4353840" y="895320"/>
              <a:ext cx="26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126" name=""/>
            <p:cNvGraphicFramePr/>
            <p:nvPr/>
          </p:nvGraphicFramePr>
          <p:xfrm>
            <a:off x="4165560" y="1123920"/>
            <a:ext cx="438120" cy="1512720"/>
          </p:xfrm>
          <a:graphic>
            <a:graphicData uri="http://schemas.openxmlformats.org/presentationml/2006/ole">
              <p:oleObj r:id="rId11" spid="">
                <p:embed/>
                <p:pic>
                  <p:nvPicPr>
                    <p:cNvPr id="127" name="" descr=""/>
                    <p:cNvPicPr/>
                    <p:nvPr/>
                  </p:nvPicPr>
                  <p:blipFill>
                    <a:blip r:embed="rId12"/>
                    <a:stretch/>
                  </p:blipFill>
                  <p:spPr>
                    <a:xfrm>
                      <a:off x="4165560" y="1123920"/>
                      <a:ext cx="438120" cy="15127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28" name=""/>
            <p:cNvSpPr/>
            <p:nvPr/>
          </p:nvSpPr>
          <p:spPr>
            <a:xfrm>
              <a:off x="4622760" y="1581120"/>
              <a:ext cx="0" cy="76212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9" name=""/>
          <p:cNvSpPr/>
          <p:nvPr/>
        </p:nvSpPr>
        <p:spPr>
          <a:xfrm>
            <a:off x="194760" y="8432640"/>
            <a:ext cx="1442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Figure S1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4935600" y="447840"/>
            <a:ext cx="925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Times New Roman"/>
              </a:rPr>
              <a:t>spoVE-P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05-22T18:59:30Z</dcterms:created>
  <dc:creator>eichenberger</dc:creator>
  <dc:description/>
  <dc:language>en-US</dc:language>
  <cp:lastModifiedBy>Patrick Eichenberger</cp:lastModifiedBy>
  <dcterms:modified xsi:type="dcterms:W3CDTF">2004-06-08T13:14:02Z</dcterms:modified>
  <cp:revision>3</cp:revision>
  <dc:subject/>
  <dc:title>Slide 1</dc:title>
</cp:coreProperties>
</file>